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08DB2-545A-4317-9CBD-0D392DA17D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96592-2B26-4F0E-BAD7-2CA24A12F1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8FA7E-B52F-48E9-AA62-AA1CDCF3F6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09B7C-AB46-437A-9043-D912F8FF42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A13A6-B543-4BDC-939C-F20F2A1E0A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4EFC7-7B1C-4E77-9916-A9AAD8C484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675312-8E06-421A-9172-384A876823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82A94-9651-489A-A45B-7765E8D317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C653C-3BBA-46A9-BF71-C9ED5C6F14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4CEC4-C8FD-4456-BF56-526A3C10CB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DFA41-4185-485A-A753-9E7D43845E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34951-ED36-47D1-A071-4AC3E44222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FE8A6F-D918-455C-93F4-51F8F3A2872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90520" y="762120"/>
          <a:ext cx="5668920" cy="6261120"/>
        </p:xfrm>
        <a:graphic>
          <a:graphicData uri="http://schemas.openxmlformats.org/drawingml/2006/table">
            <a:tbl>
              <a:tblPr/>
              <a:tblGrid>
                <a:gridCol w="1144440"/>
                <a:gridCol w="1132200"/>
                <a:gridCol w="1130040"/>
                <a:gridCol w="1130400"/>
                <a:gridCol w="1131840"/>
              </a:tblGrid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6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200µ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1.2 ± 7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4.4 ± 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6.6 ± 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.5 ± 5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6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86.2 ± 15.5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6. 4± 22.4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9.6 ± 8.2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3.4 ± 6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10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6.9 ± 15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2.4 ± 22.4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1.1 ± 9.5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1 ± 6.6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200µ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31.6 ± 26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3.5 ± 26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1.2 ± 10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1 ± 16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66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3.7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25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2.6 ± 35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7.1 ± 7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2.6 ± 8.7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6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18.9 ± 28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1.1± 3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4.1 ± 1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9.9 ± 9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7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70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200µ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7.5 ± 5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.0 ± 24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4.5 ± 13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50 ± 2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2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18.0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14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20.0 ± 32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9.5 ± 8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8.5 ± 4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6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4.3 ± 19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24.5 ± 36.2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4.3 ± 7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8.8 ± 1.5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200µ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8.4 ± 9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2 ± 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1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4.17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66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1.3 ± 12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.5 ± 1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7.4 ± 6.9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0.6 ± 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10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9.7 ± 1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6.7 ± 13.4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8.0 ± 6.6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1.0 ± 5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0" y="22788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   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9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0" y="7157520"/>
            <a:ext cx="621828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Effect of N-acetyl-cysteine (NAC, 0.5 and 5 mmol/L) intervention on menadione toxicity in each FAO disorder and control lines under variable conditions, compared to Bezafibrate. A Bonferroni analyis was performed after logarithmic transformation, to compare each cell line with intervention to Bezafibrate, and either NAC 0.5 or 5 mmol/L.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^ p&lt;0.05 *p&lt;0.01** p&lt;0.0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54:06Z</dcterms:modified>
  <cp:revision>35</cp:revision>
  <dc:subject/>
  <dc:title>Slide 1</dc:title>
</cp:coreProperties>
</file>